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2" r:id="rId2"/>
  </p:sldIdLst>
  <p:sldSz cx="6858000" cy="9144000" type="screen4x3"/>
  <p:notesSz cx="6802438" cy="9934575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159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7F7F7F"/>
    <a:srgbClr val="646464"/>
    <a:srgbClr val="8282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084" autoAdjust="0"/>
  </p:normalViewPr>
  <p:slideViewPr>
    <p:cSldViewPr snapToGrid="0" snapToObjects="1">
      <p:cViewPr varScale="1">
        <p:scale>
          <a:sx n="87" d="100"/>
          <a:sy n="87" d="100"/>
        </p:scale>
        <p:origin x="648" y="72"/>
      </p:cViewPr>
      <p:guideLst>
        <p:guide orient="horz" pos="2880"/>
        <p:guide pos="2160"/>
        <p:guide orient="horz" pos="159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47343F-9011-4E48-ACD0-AFDBFF8B6C7E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1425"/>
            <a:ext cx="2513012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467D0-B869-419D-8DA9-B631581B19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186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873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52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469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4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562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5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60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19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747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419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4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lt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645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772" y="745639"/>
            <a:ext cx="2526402" cy="2526402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8300" y="748687"/>
            <a:ext cx="2526402" cy="2522134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3430028" y="1262711"/>
            <a:ext cx="353943" cy="125771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+ (%) in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DC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275669" y="477360"/>
            <a:ext cx="11961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LR9- mediated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19876" y="1262711"/>
            <a:ext cx="353943" cy="125771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+ (%) in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DC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327417" y="465984"/>
            <a:ext cx="11961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LR7- mediated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965984" y="2924360"/>
            <a:ext cx="8969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re-treatment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ith IL-3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0.1 ng/mL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for 24hr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101460" y="2924360"/>
            <a:ext cx="896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re-treatment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731415" y="2031358"/>
            <a:ext cx="450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11" name="直線コネクタ 10"/>
          <p:cNvCxnSpPr/>
          <p:nvPr/>
        </p:nvCxnSpPr>
        <p:spPr>
          <a:xfrm>
            <a:off x="1522217" y="1990997"/>
            <a:ext cx="9333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4607221" y="1085005"/>
            <a:ext cx="450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19" name="直線コネクタ 18"/>
          <p:cNvCxnSpPr/>
          <p:nvPr/>
        </p:nvCxnSpPr>
        <p:spPr>
          <a:xfrm>
            <a:off x="4398023" y="1044644"/>
            <a:ext cx="9333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4815787" y="2924360"/>
            <a:ext cx="10235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re-treatment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ith IL-3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0.1 ng/mL)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for 24hr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999390" y="2924360"/>
            <a:ext cx="896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re-treatment</a:t>
            </a:r>
          </a:p>
        </p:txBody>
      </p:sp>
    </p:spTree>
    <p:extLst>
      <p:ext uri="{BB962C8B-B14F-4D97-AF65-F5344CB8AC3E}">
        <p14:creationId xmlns:p14="http://schemas.microsoft.com/office/powerpoint/2010/main" val="281102568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62</TotalTime>
  <Words>46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ホワイト</vt:lpstr>
      <vt:lpstr>PowerPoint プレゼンテーション</vt:lpstr>
    </vt:vector>
  </TitlesOfParts>
  <Company>UOE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TA SHIGERU</dc:creator>
  <cp:lastModifiedBy>圭 阪田</cp:lastModifiedBy>
  <cp:revision>283</cp:revision>
  <cp:lastPrinted>2017-04-10T01:20:45Z</cp:lastPrinted>
  <dcterms:created xsi:type="dcterms:W3CDTF">2016-08-30T03:40:23Z</dcterms:created>
  <dcterms:modified xsi:type="dcterms:W3CDTF">2018-07-25T02:24:12Z</dcterms:modified>
</cp:coreProperties>
</file>